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13E431-579B-43A6-BFE9-D2F0D61253B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A90D44-AB10-4919-9CF7-EF6FAEB27BD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F662C3-7782-4D72-A55D-54C7A7E33BC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20A8E2-3546-429C-9391-42E6BDB618B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C96DD9-05BE-4AEC-A8B4-8918D8384E8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CF0F13-5853-40DA-8A8D-7E7CB3EE2E6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44B884-4683-41C3-A704-F677E278167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9CE477-B2A0-4D4D-B411-E5CADE13519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CF58C4-DD4F-49AD-843E-80CC9EBD19B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844A1C-3199-4750-AF95-D0BEC30CC4F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3E612B-2134-4C89-AD5D-5D23A024641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8C7AF7-B99A-433D-95B8-3E11D194E9A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6D18DF17-025E-4B09-B2C0-5038C86615C8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0" y="1738440"/>
          <a:ext cx="6635880" cy="4614840"/>
        </p:xfrm>
        <a:graphic>
          <a:graphicData uri="http://schemas.openxmlformats.org/drawingml/2006/table">
            <a:tbl>
              <a:tblPr/>
              <a:tblGrid>
                <a:gridCol w="56880"/>
                <a:gridCol w="606960"/>
                <a:gridCol w="101880"/>
                <a:gridCol w="570600"/>
                <a:gridCol w="106560"/>
                <a:gridCol w="389880"/>
                <a:gridCol w="185760"/>
                <a:gridCol w="353880"/>
                <a:gridCol w="350280"/>
                <a:gridCol w="168480"/>
                <a:gridCol w="565920"/>
                <a:gridCol w="607320"/>
                <a:gridCol w="127080"/>
                <a:gridCol w="570600"/>
                <a:gridCol w="111240"/>
                <a:gridCol w="554760"/>
                <a:gridCol w="179640"/>
                <a:gridCol w="466200"/>
                <a:gridCol w="268200"/>
                <a:gridCol w="239760"/>
                <a:gridCol w="56880"/>
              </a:tblGrid>
              <a:tr h="406440">
                <a:tc gridSpan="15">
                  <a:txBody>
                    <a:bodyPr lIns="10440" rIns="10440" tIns="104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omparison of means of FOXA1 methylation between BRCA1 and BRCA2/x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3440">
                <a:tc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3"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4880">
                <a:tc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12">
                  <a:txBody>
                    <a:bodyPr lIns="10440" rIns="10440" tIns="104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roup Statistic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31920">
                <a:tc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 lIns="10440" rIns="10440" tIns="1044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ample_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ea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td. Deviatio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td. Error Mea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2000">
                <a:tc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2" rowSpan="2">
                  <a:txBody>
                    <a:bodyPr lIns="10440" rIns="10440" tIns="1044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OXA1 methylatio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 row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RCA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363470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3241394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977317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4880">
                <a:tc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 grid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other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0.014803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3527578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752082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85840">
                <a:tc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84040">
                <a:tc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5240">
                <a:tc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20">
                  <a:txBody>
                    <a:bodyPr lIns="10440" rIns="10440" tIns="104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ndependent Samples Tes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468360">
                <a:tc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3" rowSpan="4">
                  <a:txBody>
                    <a:bodyPr lIns="10440" rIns="10440" tIns="1044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93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 row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 row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4">
                  <a:txBody>
                    <a:bodyPr lIns="10440" rIns="10440" tIns="104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evene's Test for Equality of Variance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13">
                  <a:txBody>
                    <a:bodyPr lIns="10440" rIns="10440" tIns="104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-test for Equality of Mean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465120">
                <a:tc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 grid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 rowSpan="3">
                  <a:txBody>
                    <a:bodyPr lIns="10440" rIns="10440" tIns="104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 row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 rowSpan="3">
                  <a:txBody>
                    <a:bodyPr lIns="10440" rIns="10440" tIns="104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ig.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 row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 rowSpan="3">
                  <a:txBody>
                    <a:bodyPr lIns="10440" rIns="10440" tIns="104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 row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rowSpan="3">
                  <a:txBody>
                    <a:bodyPr lIns="10440" rIns="10440" tIns="104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f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rowSpan="3">
                  <a:txBody>
                    <a:bodyPr lIns="10440" rIns="10440" tIns="104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ig. (2-tailed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gridSpan="2" rowSpan="3">
                  <a:txBody>
                    <a:bodyPr lIns="10440" rIns="10440" tIns="104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ean Differenc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 row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 rowSpan="3">
                  <a:txBody>
                    <a:bodyPr lIns="10440" rIns="10440" tIns="104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td. Error Differenc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 row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5" rowSpan="2">
                  <a:txBody>
                    <a:bodyPr lIns="10440" rIns="10440" tIns="104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5% Confidence Interval of the Differenc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 row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 row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 row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 row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01520">
                <a:tc rowSpan="2"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 grid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grid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grid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grid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grid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grid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grid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634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grid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grid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grid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grid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grid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grid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owe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3">
                  <a:txBody>
                    <a:bodyPr lIns="10440" rIns="10440" tIns="104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Uppe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476280">
                <a:tc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2" rowSpan="3">
                  <a:txBody>
                    <a:bodyPr lIns="10440" rIns="10440" tIns="1044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OXA1 methylatio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 row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rowSpan="2">
                  <a:txBody>
                    <a:bodyPr lIns="10440" rIns="10440" tIns="1044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qual variances assume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gridSpan="2" rowSpan="2">
                  <a:txBody>
                    <a:bodyPr lIns="10440" rIns="10440" tIns="1044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3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 row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 rowSpan="2">
                  <a:txBody>
                    <a:bodyPr lIns="10440" rIns="10440" tIns="1044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8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 row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 rowSpan="2">
                  <a:txBody>
                    <a:bodyPr lIns="10440" rIns="10440" tIns="1044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9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 row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rowSpan="2">
                  <a:txBody>
                    <a:bodyPr lIns="10440" rIns="10440" tIns="1044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 lIns="10440" rIns="10440" tIns="1044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0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gridSpan="2" rowSpan="2">
                  <a:txBody>
                    <a:bodyPr lIns="10440" rIns="10440" tIns="1044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37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 row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 rowSpan="2">
                  <a:txBody>
                    <a:bodyPr lIns="10440" rIns="10440" tIns="1044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12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 row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 rowSpan="2">
                  <a:txBody>
                    <a:bodyPr lIns="10440" rIns="10440" tIns="1044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11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 row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3" rowSpan="2">
                  <a:txBody>
                    <a:bodyPr lIns="10440" rIns="10440" tIns="1044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63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 row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 row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92240">
                <a:tc rowSpan="2"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 grid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grid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grid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grid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grid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grid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grid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grid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6192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grid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0440" rIns="10440" tIns="1044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qual variances not assume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gridSpan="2">
                  <a:txBody>
                    <a:bodyPr lIns="10440" rIns="10440" tIns="1044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.06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0440" rIns="10440" tIns="1044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1.72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440" rIns="10440" tIns="1044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0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gridSpan="2">
                  <a:txBody>
                    <a:bodyPr lIns="10440" rIns="10440" tIns="1044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37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12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12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3">
                  <a:txBody>
                    <a:bodyPr lIns="10440" rIns="10440" tIns="1044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63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</a:tbl>
          </a:graphicData>
        </a:graphic>
      </p:graphicFrame>
      <p:sp>
        <p:nvSpPr>
          <p:cNvPr id="42" name="TextBox 2"/>
          <p:cNvSpPr/>
          <p:nvPr/>
        </p:nvSpPr>
        <p:spPr>
          <a:xfrm>
            <a:off x="5081040" y="9609120"/>
            <a:ext cx="1870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 S1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10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11-16T23:48:49Z</dcterms:created>
  <dc:creator>Jade Gong</dc:creator>
  <dc:description/>
  <dc:language>en-US</dc:language>
  <cp:lastModifiedBy>Eric Lam</cp:lastModifiedBy>
  <cp:lastPrinted>2014-09-26T09:57:40Z</cp:lastPrinted>
  <dcterms:modified xsi:type="dcterms:W3CDTF">2014-10-01T11:10:43Z</dcterms:modified>
  <cp:revision>592</cp:revision>
  <dc:subject/>
  <dc:title>PowerPoint Presentation</dc:title>
</cp:coreProperties>
</file>